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061" autoAdjust="0"/>
  </p:normalViewPr>
  <p:slideViewPr>
    <p:cSldViewPr snapToGrid="0">
      <p:cViewPr varScale="1">
        <p:scale>
          <a:sx n="161" d="100"/>
          <a:sy n="161" d="100"/>
        </p:scale>
        <p:origin x="437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450EAF-0E2F-4A3D-A87B-E9544BA6DDCC}" type="datetimeFigureOut">
              <a:rPr lang="en-CA" smtClean="0"/>
              <a:t>2025-04-17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CF470B-2BA7-4A8C-912D-0AFDA7F8FB2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95011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CF470B-2BA7-4A8C-912D-0AFDA7F8FB20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748313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3861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4214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41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715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35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3405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806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2720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7177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387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466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FDBB79-4890-4692-8154-D9A583748A76}" type="datetimeFigureOut">
              <a:rPr lang="zh-CN" altLang="en-US" smtClean="0"/>
              <a:t>2025/4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871E55-EF2E-48D6-8AB4-D5D46BAC46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1079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图片包含 桌子, 甜甜圈, 食物, 盘子&#10;&#10;AI 生成的内容可能不正确。">
            <a:extLst>
              <a:ext uri="{FF2B5EF4-FFF2-40B4-BE49-F238E27FC236}">
                <a16:creationId xmlns:a16="http://schemas.microsoft.com/office/drawing/2014/main" id="{824840D3-8A3B-F103-E029-7A689198E6E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7753" y="2449229"/>
            <a:ext cx="1664514" cy="1409852"/>
          </a:xfrm>
          <a:prstGeom prst="rect">
            <a:avLst/>
          </a:prstGeom>
        </p:spPr>
      </p:pic>
      <p:pic>
        <p:nvPicPr>
          <p:cNvPr id="8" name="图片 7" descr="图片包含 食物, 桌子, 甜甜圈, 盘子&#10;&#10;AI 生成的内容可能不正确。">
            <a:extLst>
              <a:ext uri="{FF2B5EF4-FFF2-40B4-BE49-F238E27FC236}">
                <a16:creationId xmlns:a16="http://schemas.microsoft.com/office/drawing/2014/main" id="{677FBBF3-EE38-84BA-28E6-41E77553C3C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6913" y="2449229"/>
            <a:ext cx="1673282" cy="1409852"/>
          </a:xfrm>
          <a:prstGeom prst="rect">
            <a:avLst/>
          </a:prstGeom>
        </p:spPr>
      </p:pic>
      <p:pic>
        <p:nvPicPr>
          <p:cNvPr id="10" name="图片 9" descr="模糊的图片&#10;&#10;AI 生成的内容可能不正确。">
            <a:extLst>
              <a:ext uri="{FF2B5EF4-FFF2-40B4-BE49-F238E27FC236}">
                <a16:creationId xmlns:a16="http://schemas.microsoft.com/office/drawing/2014/main" id="{B0F45BDA-FEF4-7709-3096-44B1EC6C4C5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4840" y="2449228"/>
            <a:ext cx="1673282" cy="1395464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B655707-EC53-46CC-B697-D0DF205D425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67753" y="573599"/>
            <a:ext cx="5220370" cy="161877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33E6F2C-94A8-3660-3EE8-D80FCD4A006E}"/>
              </a:ext>
            </a:extLst>
          </p:cNvPr>
          <p:cNvSpPr txBox="1"/>
          <p:nvPr/>
        </p:nvSpPr>
        <p:spPr>
          <a:xfrm>
            <a:off x="1649283" y="435099"/>
            <a:ext cx="25717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FFCE7C4-0608-891F-E32D-09F4D6C4DF3D}"/>
              </a:ext>
            </a:extLst>
          </p:cNvPr>
          <p:cNvSpPr txBox="1"/>
          <p:nvPr/>
        </p:nvSpPr>
        <p:spPr>
          <a:xfrm>
            <a:off x="1649283" y="2276439"/>
            <a:ext cx="25717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BFE4932-47E5-FED4-E57E-6927A67442A6}"/>
              </a:ext>
            </a:extLst>
          </p:cNvPr>
          <p:cNvSpPr txBox="1"/>
          <p:nvPr/>
        </p:nvSpPr>
        <p:spPr>
          <a:xfrm>
            <a:off x="1906458" y="4101541"/>
            <a:ext cx="5343428" cy="14414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1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mputed tomography images of a 58-year-old male patient with supraglottic laryngeal squamous cell carcinoma (LSCC)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region of interest (ROI) was manually delineated, layer by layer, on the images (red area), via slice-by-slice contouring of the tumor margins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rans-nasal fiberoptic images used by 2 experienced radiologists as guides to delineate tumor boundaries. </a:t>
            </a: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991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73</Words>
  <Application>Microsoft Office PowerPoint</Application>
  <PresentationFormat>全屏显示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赟 梁</dc:creator>
  <cp:lastModifiedBy>sheng he</cp:lastModifiedBy>
  <cp:revision>6</cp:revision>
  <dcterms:created xsi:type="dcterms:W3CDTF">2025-04-12T14:25:28Z</dcterms:created>
  <dcterms:modified xsi:type="dcterms:W3CDTF">2025-04-17T09:03:26Z</dcterms:modified>
</cp:coreProperties>
</file>